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89000" autoAdjust="0"/>
  </p:normalViewPr>
  <p:slideViewPr>
    <p:cSldViewPr>
      <p:cViewPr>
        <p:scale>
          <a:sx n="100" d="100"/>
          <a:sy n="100" d="100"/>
        </p:scale>
        <p:origin x="-1026" y="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6DADBB-D4AF-46D1-9BEE-DE69B469763E}" type="datetimeFigureOut">
              <a:rPr lang="en-US" smtClean="0"/>
              <a:pPr/>
              <a:t>9/5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5AEF30-9B37-4675-A0D8-3625D09D9FE0}" type="slidenum">
              <a:rPr lang="en-GB" smtClean="0"/>
              <a:pPr/>
              <a:t>&lt;#&gt;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85AEF30-9B37-4675-A0D8-3625D09D9FE0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6BBC1-465E-4798-8D47-2824165874D8}" type="datetimeFigureOut">
              <a:rPr lang="en-US" smtClean="0"/>
              <a:pPr/>
              <a:t>9/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E3231-5D71-4AED-AC2A-644E92ECCF1B}" type="slidenum">
              <a:rPr lang="en-GB" smtClean="0"/>
              <a:pPr/>
              <a:t>&lt;#&gt;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6BBC1-465E-4798-8D47-2824165874D8}" type="datetimeFigureOut">
              <a:rPr lang="en-US" smtClean="0"/>
              <a:pPr/>
              <a:t>9/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E3231-5D71-4AED-AC2A-644E92ECCF1B}" type="slidenum">
              <a:rPr lang="en-GB" smtClean="0"/>
              <a:pPr/>
              <a:t>&lt;#&gt;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6BBC1-465E-4798-8D47-2824165874D8}" type="datetimeFigureOut">
              <a:rPr lang="en-US" smtClean="0"/>
              <a:pPr/>
              <a:t>9/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E3231-5D71-4AED-AC2A-644E92ECCF1B}" type="slidenum">
              <a:rPr lang="en-GB" smtClean="0"/>
              <a:pPr/>
              <a:t>&lt;#&gt;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6BBC1-465E-4798-8D47-2824165874D8}" type="datetimeFigureOut">
              <a:rPr lang="en-US" smtClean="0"/>
              <a:pPr/>
              <a:t>9/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E3231-5D71-4AED-AC2A-644E92ECCF1B}" type="slidenum">
              <a:rPr lang="en-GB" smtClean="0"/>
              <a:pPr/>
              <a:t>&lt;#&gt;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6BBC1-465E-4798-8D47-2824165874D8}" type="datetimeFigureOut">
              <a:rPr lang="en-US" smtClean="0"/>
              <a:pPr/>
              <a:t>9/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E3231-5D71-4AED-AC2A-644E92ECCF1B}" type="slidenum">
              <a:rPr lang="en-GB" smtClean="0"/>
              <a:pPr/>
              <a:t>&lt;#&gt;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6BBC1-465E-4798-8D47-2824165874D8}" type="datetimeFigureOut">
              <a:rPr lang="en-US" smtClean="0"/>
              <a:pPr/>
              <a:t>9/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E3231-5D71-4AED-AC2A-644E92ECCF1B}" type="slidenum">
              <a:rPr lang="en-GB" smtClean="0"/>
              <a:pPr/>
              <a:t>&lt;#&gt;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6BBC1-465E-4798-8D47-2824165874D8}" type="datetimeFigureOut">
              <a:rPr lang="en-US" smtClean="0"/>
              <a:pPr/>
              <a:t>9/5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E3231-5D71-4AED-AC2A-644E92ECCF1B}" type="slidenum">
              <a:rPr lang="en-GB" smtClean="0"/>
              <a:pPr/>
              <a:t>&lt;#&gt;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6BBC1-465E-4798-8D47-2824165874D8}" type="datetimeFigureOut">
              <a:rPr lang="en-US" smtClean="0"/>
              <a:pPr/>
              <a:t>9/5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E3231-5D71-4AED-AC2A-644E92ECCF1B}" type="slidenum">
              <a:rPr lang="en-GB" smtClean="0"/>
              <a:pPr/>
              <a:t>&lt;#&gt;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6BBC1-465E-4798-8D47-2824165874D8}" type="datetimeFigureOut">
              <a:rPr lang="en-US" smtClean="0"/>
              <a:pPr/>
              <a:t>9/5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E3231-5D71-4AED-AC2A-644E92ECCF1B}" type="slidenum">
              <a:rPr lang="en-GB" smtClean="0"/>
              <a:pPr/>
              <a:t>&lt;#&gt;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6BBC1-465E-4798-8D47-2824165874D8}" type="datetimeFigureOut">
              <a:rPr lang="en-US" smtClean="0"/>
              <a:pPr/>
              <a:t>9/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E3231-5D71-4AED-AC2A-644E92ECCF1B}" type="slidenum">
              <a:rPr lang="en-GB" smtClean="0"/>
              <a:pPr/>
              <a:t>&lt;#&gt;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6BBC1-465E-4798-8D47-2824165874D8}" type="datetimeFigureOut">
              <a:rPr lang="en-US" smtClean="0"/>
              <a:pPr/>
              <a:t>9/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E3231-5D71-4AED-AC2A-644E92ECCF1B}" type="slidenum">
              <a:rPr lang="en-GB" smtClean="0"/>
              <a:pPr/>
              <a:t>&lt;#&gt;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6BBC1-465E-4798-8D47-2824165874D8}" type="datetimeFigureOut">
              <a:rPr lang="en-US" smtClean="0"/>
              <a:pPr/>
              <a:t>9/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8E3231-5D71-4AED-AC2A-644E92ECCF1B}" type="slidenum">
              <a:rPr lang="en-GB" smtClean="0"/>
              <a:pPr/>
              <a:t>&lt;#&gt;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5214942" y="1357298"/>
          <a:ext cx="3481161" cy="4143433"/>
        </p:xfrm>
        <a:graphic>
          <a:graphicData uri="http://schemas.openxmlformats.org/drawingml/2006/table">
            <a:tbl>
              <a:tblPr/>
              <a:tblGrid>
                <a:gridCol w="1208299"/>
                <a:gridCol w="194887"/>
                <a:gridCol w="175398"/>
                <a:gridCol w="168089"/>
                <a:gridCol w="168089"/>
                <a:gridCol w="165653"/>
                <a:gridCol w="168089"/>
                <a:gridCol w="185143"/>
                <a:gridCol w="168089"/>
                <a:gridCol w="175398"/>
                <a:gridCol w="175398"/>
                <a:gridCol w="165653"/>
                <a:gridCol w="194887"/>
                <a:gridCol w="168089"/>
              </a:tblGrid>
              <a:tr h="19590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AA starting from start </a:t>
                      </a:r>
                      <a:r>
                        <a:rPr lang="en-GB" sz="700" b="0" i="0" u="none" strike="noStrike" dirty="0" err="1">
                          <a:solidFill>
                            <a:srgbClr val="000000"/>
                          </a:solidFill>
                          <a:latin typeface="Arial"/>
                        </a:rPr>
                        <a:t>codon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40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24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42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43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44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45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46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47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248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49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12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313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14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California/07/2009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V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G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S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G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Y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Q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61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2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65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6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95/2010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63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62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0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8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13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03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0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3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46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64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1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6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19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1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4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52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10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5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3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58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17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16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15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7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2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51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22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04/2011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6842" marR="6842" marT="6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42844" y="1285860"/>
            <a:ext cx="3882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a)</a:t>
            </a:r>
            <a:endParaRPr lang="en-GB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4857752" y="1357298"/>
            <a:ext cx="571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smtClean="0"/>
              <a:t>b)</a:t>
            </a:r>
            <a:endParaRPr lang="en-GB" sz="1400" dirty="0"/>
          </a:p>
        </p:txBody>
      </p:sp>
      <p:graphicFrame>
        <p:nvGraphicFramePr>
          <p:cNvPr id="8" name="Table 7"/>
          <p:cNvGraphicFramePr>
            <a:graphicFrameLocks noGrp="1"/>
          </p:cNvGraphicFramePr>
          <p:nvPr/>
        </p:nvGraphicFramePr>
        <p:xfrm>
          <a:off x="571472" y="1357298"/>
          <a:ext cx="4124934" cy="4058168"/>
        </p:xfrm>
        <a:graphic>
          <a:graphicData uri="http://schemas.openxmlformats.org/drawingml/2006/table">
            <a:tbl>
              <a:tblPr/>
              <a:tblGrid>
                <a:gridCol w="1516142"/>
                <a:gridCol w="149742"/>
                <a:gridCol w="149742"/>
                <a:gridCol w="149742"/>
                <a:gridCol w="161441"/>
                <a:gridCol w="168460"/>
                <a:gridCol w="177819"/>
                <a:gridCol w="187178"/>
                <a:gridCol w="149742"/>
                <a:gridCol w="149742"/>
                <a:gridCol w="177819"/>
                <a:gridCol w="168460"/>
                <a:gridCol w="177819"/>
                <a:gridCol w="159102"/>
                <a:gridCol w="161441"/>
                <a:gridCol w="161441"/>
                <a:gridCol w="159102"/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AA position excluding signal peptide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80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8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82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183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84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185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86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96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197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98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99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00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0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02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203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04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California/07/2009(CLADE-1)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H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H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S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S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Y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V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V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G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S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S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65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64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63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62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46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6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4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19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8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6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61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2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0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03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A/Sendai/TU13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3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1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1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0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52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95/2010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10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04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3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2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17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15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16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27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35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Sendai/TU51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52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A/Sendai/TU58/2011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</a:p>
                  </a:txBody>
                  <a:tcPr marL="7031" marR="7031" marT="70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251520" y="500042"/>
            <a:ext cx="81066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Supplementary</a:t>
            </a:r>
            <a:r>
              <a:rPr kumimoji="1" lang="ja-JP" altLang="en-US" smtClean="0"/>
              <a:t> </a:t>
            </a:r>
            <a:r>
              <a:rPr lang="en-US" dirty="0" smtClean="0"/>
              <a:t>Table 2: Important amino acid changes of Sendai isolates in 2010-2011. a) For HA1 gene and b) for NA gene.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571472" y="5715016"/>
            <a:ext cx="85725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haded area represents the main amino acid substitution and cluster specific mutations</a:t>
            </a:r>
            <a:endParaRPr lang="en-GB" sz="8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3</TotalTime>
  <Words>1106</Words>
  <Application>Microsoft Office PowerPoint</Application>
  <PresentationFormat>画面に合わせる (4:3)</PresentationFormat>
  <Paragraphs>1059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Theme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r Sensei</dc:title>
  <dc:creator>IronaPC</dc:creator>
  <cp:lastModifiedBy>Akira</cp:lastModifiedBy>
  <cp:revision>210</cp:revision>
  <dcterms:created xsi:type="dcterms:W3CDTF">2012-02-16T12:15:16Z</dcterms:created>
  <dcterms:modified xsi:type="dcterms:W3CDTF">2013-09-05T13:03:04Z</dcterms:modified>
</cp:coreProperties>
</file>